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5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62911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52211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5/07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581689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Vincent and </a:t>
            </a:r>
            <a:r>
              <a:rPr lang="en-GB" dirty="0" err="1"/>
              <a:t>Yaghootkar</a:t>
            </a:r>
            <a:r>
              <a:rPr lang="en-GB" dirty="0"/>
              <a:t> (2020) Diabetologia DOI 10.1007/s00125-020-05228-y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relationship between type 2 diabetes and cancer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9261245-ED6A-4622-885E-5960D8D200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9439" y="1124744"/>
            <a:ext cx="8118648" cy="44508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assumptions of the MR approac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F89F113-0853-4275-9633-166486340D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1804" y="1412776"/>
            <a:ext cx="8100392" cy="377158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A625E87-D8CF-44CB-8A3C-799CE9A7ADBC}"/>
              </a:ext>
            </a:extLst>
          </p:cNvPr>
          <p:cNvSpPr txBox="1"/>
          <p:nvPr/>
        </p:nvSpPr>
        <p:spPr>
          <a:xfrm>
            <a:off x="251520" y="5581689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Vincent and </a:t>
            </a:r>
            <a:r>
              <a:rPr lang="en-GB" dirty="0" err="1"/>
              <a:t>Yaghootkar</a:t>
            </a:r>
            <a:r>
              <a:rPr lang="en-GB" dirty="0"/>
              <a:t> (2020) Diabetologia DOI 10.1007/s00125-020-05228-y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6677765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ummary of evidence from MR studies supporting an association between type 2 diabetes (or associated metabolic traits) and cancer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87C704-B8F8-41D8-AB27-BD759C9F98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6115" y="1006950"/>
            <a:ext cx="7107794" cy="484409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FD8DBA2-E073-4361-AB29-D0F1F55F711C}"/>
              </a:ext>
            </a:extLst>
          </p:cNvPr>
          <p:cNvSpPr txBox="1"/>
          <p:nvPr/>
        </p:nvSpPr>
        <p:spPr>
          <a:xfrm>
            <a:off x="251520" y="5581689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Vincent and </a:t>
            </a:r>
            <a:r>
              <a:rPr lang="en-GB" dirty="0" err="1"/>
              <a:t>Yaghootkar</a:t>
            </a:r>
            <a:r>
              <a:rPr lang="en-GB" dirty="0"/>
              <a:t> (2020) Diabetologia DOI 10.1007/s00125-020-05228-y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807491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</TotalTime>
  <Words>158</Words>
  <Application>Microsoft Office PowerPoint</Application>
  <PresentationFormat>On-screen Show (4:3)</PresentationFormat>
  <Paragraphs>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7</cp:revision>
  <dcterms:created xsi:type="dcterms:W3CDTF">2016-06-15T12:53:43Z</dcterms:created>
  <dcterms:modified xsi:type="dcterms:W3CDTF">2020-07-15T15:39:02Z</dcterms:modified>
</cp:coreProperties>
</file>